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553CB-D551-4EA5-86A4-7A7F999744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3E874-9376-42BB-B318-87CCECE8E4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E25EE-04A8-4F22-8D42-6D15AF1515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A04D1-9689-483C-B124-FF62192CB5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789B5-BE19-4183-9981-9BF28EC73E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17791-40D1-432F-AAE6-C145C30D59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48228-53DA-425B-8309-041B6A3E7E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168CA-BEE3-4041-8452-0089824C3B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5E298-5364-4CAF-B1D6-524EF266B6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8A194-10CA-4FC6-BADF-E6763AD657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8C776-8F91-4B5F-A4A8-ACB472E930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1C801-E46A-41D7-92A4-CE6C624C27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62B117-7306-48C3-A562-0E4C8A853BC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4648320" y="3657240"/>
            <a:ext cx="3657600" cy="2438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>
              <a:lnSpc>
                <a:spcPct val="80000"/>
              </a:lnSpc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9</a:t>
            </a:r>
            <a:r>
              <a:rPr b="0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representative data of microarray hybridization and qRT-PCR. </a:t>
            </a:r>
            <a:r>
              <a:rPr b="1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Part of the image of microarray hybridization. </a:t>
            </a:r>
            <a:r>
              <a:rPr b="1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catter plot of log intensities across a array. </a:t>
            </a:r>
            <a:r>
              <a:rPr b="1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2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Real time PCR curve.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4" descr="1.jpg"/>
          <p:cNvPicPr/>
          <p:nvPr/>
        </p:nvPicPr>
        <p:blipFill>
          <a:blip r:embed="rId1"/>
          <a:stretch/>
        </p:blipFill>
        <p:spPr>
          <a:xfrm>
            <a:off x="380880" y="533520"/>
            <a:ext cx="3919680" cy="28526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2.jpg"/>
          <p:cNvPicPr/>
          <p:nvPr/>
        </p:nvPicPr>
        <p:blipFill>
          <a:blip r:embed="rId2"/>
          <a:stretch/>
        </p:blipFill>
        <p:spPr>
          <a:xfrm>
            <a:off x="4952880" y="533520"/>
            <a:ext cx="3181320" cy="28954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7" descr="3.jpg"/>
          <p:cNvPicPr/>
          <p:nvPr/>
        </p:nvPicPr>
        <p:blipFill>
          <a:blip r:embed="rId3"/>
          <a:stretch/>
        </p:blipFill>
        <p:spPr>
          <a:xfrm>
            <a:off x="304920" y="3581280"/>
            <a:ext cx="4114800" cy="2571840"/>
          </a:xfrm>
          <a:prstGeom prst="rect">
            <a:avLst/>
          </a:prstGeom>
          <a:ln w="0">
            <a:noFill/>
          </a:ln>
        </p:spPr>
      </p:pic>
      <p:sp>
        <p:nvSpPr>
          <p:cNvPr id="45" name="TextBox 8"/>
          <p:cNvSpPr/>
          <p:nvPr/>
        </p:nvSpPr>
        <p:spPr>
          <a:xfrm>
            <a:off x="3965400" y="3013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7796520" y="30337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3986640" y="56037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mpa</dc:creator>
  <dc:description/>
  <dc:language>en-US</dc:language>
  <cp:lastModifiedBy>Prof. Sampa Das</cp:lastModifiedBy>
  <dcterms:modified xsi:type="dcterms:W3CDTF">2011-12-19T09:37:17Z</dcterms:modified>
  <cp:revision>7</cp:revision>
  <dc:subject/>
  <dc:title>Slide 1</dc:title>
</cp:coreProperties>
</file>